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60"/>
  </p:normalViewPr>
  <p:slideViewPr>
    <p:cSldViewPr snapToObjects="1">
      <p:cViewPr>
        <p:scale>
          <a:sx n="120" d="100"/>
          <a:sy n="120" d="100"/>
        </p:scale>
        <p:origin x="-1422" y="-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1C968C-6B50-AD4E-8E2A-574BD3A93548}" type="datetimeFigureOut">
              <a:rPr lang="en-US" smtClean="0"/>
              <a:pPr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016CE6-36F2-A14B-904B-B9AE2C5C0A8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331230" y="345823"/>
            <a:ext cx="1150816" cy="505438"/>
            <a:chOff x="1607329" y="2922"/>
            <a:chExt cx="1150816" cy="505438"/>
          </a:xfrm>
        </p:grpSpPr>
        <p:sp>
          <p:nvSpPr>
            <p:cNvPr id="59" name="Rounded Rectangle 58"/>
            <p:cNvSpPr/>
            <p:nvPr/>
          </p:nvSpPr>
          <p:spPr>
            <a:xfrm>
              <a:off x="1607329" y="2922"/>
              <a:ext cx="1150816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0" name="Rounded Rectangle 4"/>
            <p:cNvSpPr/>
            <p:nvPr/>
          </p:nvSpPr>
          <p:spPr>
            <a:xfrm>
              <a:off x="1622133" y="17726"/>
              <a:ext cx="1121208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err="1" smtClean="0"/>
                <a:t>MiSeq</a:t>
              </a:r>
              <a:r>
                <a:rPr lang="en-US" sz="1000" b="1" kern="1200" dirty="0" smtClean="0"/>
                <a:t> FASTQ file</a:t>
              </a:r>
              <a:endParaRPr lang="en-US" sz="1000" b="1" kern="1200" dirty="0"/>
            </a:p>
          </p:txBody>
        </p:sp>
      </p:grpSp>
      <p:sp>
        <p:nvSpPr>
          <p:cNvPr id="3" name="Straight Connector 5"/>
          <p:cNvSpPr/>
          <p:nvPr/>
        </p:nvSpPr>
        <p:spPr>
          <a:xfrm>
            <a:off x="2860918" y="851262"/>
            <a:ext cx="91440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45720" y="0"/>
                </a:moveTo>
                <a:lnTo>
                  <a:pt x="45720" y="202175"/>
                </a:lnTo>
              </a:path>
            </a:pathLst>
          </a:custGeom>
          <a:noFill/>
        </p:spPr>
        <p:style>
          <a:lnRef idx="2">
            <a:schemeClr val="dk1">
              <a:shade val="6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4" name="Group 3"/>
          <p:cNvGrpSpPr/>
          <p:nvPr/>
        </p:nvGrpSpPr>
        <p:grpSpPr>
          <a:xfrm>
            <a:off x="2331230" y="1053438"/>
            <a:ext cx="1150816" cy="505438"/>
            <a:chOff x="1607329" y="710537"/>
            <a:chExt cx="1150816" cy="505438"/>
          </a:xfrm>
        </p:grpSpPr>
        <p:sp>
          <p:nvSpPr>
            <p:cNvPr id="57" name="Rounded Rectangle 56"/>
            <p:cNvSpPr/>
            <p:nvPr/>
          </p:nvSpPr>
          <p:spPr>
            <a:xfrm>
              <a:off x="1607329" y="710537"/>
              <a:ext cx="1150816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8" name="Rounded Rectangle 7"/>
            <p:cNvSpPr/>
            <p:nvPr/>
          </p:nvSpPr>
          <p:spPr>
            <a:xfrm>
              <a:off x="1622133" y="725341"/>
              <a:ext cx="1121208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Removal of </a:t>
              </a:r>
            </a:p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RNA 3’ Adapter</a:t>
              </a:r>
              <a:endParaRPr lang="en-US" sz="1000" b="1" kern="1200" dirty="0"/>
            </a:p>
          </p:txBody>
        </p:sp>
      </p:grpSp>
      <p:sp>
        <p:nvSpPr>
          <p:cNvPr id="5" name="Straight Connector 8"/>
          <p:cNvSpPr/>
          <p:nvPr/>
        </p:nvSpPr>
        <p:spPr>
          <a:xfrm>
            <a:off x="1931499" y="1558877"/>
            <a:ext cx="975139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975139" y="0"/>
                </a:moveTo>
                <a:lnTo>
                  <a:pt x="975139" y="101087"/>
                </a:lnTo>
                <a:lnTo>
                  <a:pt x="0" y="101087"/>
                </a:lnTo>
                <a:lnTo>
                  <a:pt x="0" y="202175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6" name="Group 5"/>
          <p:cNvGrpSpPr/>
          <p:nvPr/>
        </p:nvGrpSpPr>
        <p:grpSpPr>
          <a:xfrm>
            <a:off x="1070083" y="1761052"/>
            <a:ext cx="1722831" cy="505438"/>
            <a:chOff x="346182" y="1418151"/>
            <a:chExt cx="1722831" cy="505438"/>
          </a:xfrm>
        </p:grpSpPr>
        <p:sp>
          <p:nvSpPr>
            <p:cNvPr id="55" name="Rounded Rectangle 54"/>
            <p:cNvSpPr/>
            <p:nvPr/>
          </p:nvSpPr>
          <p:spPr>
            <a:xfrm>
              <a:off x="346182" y="1418151"/>
              <a:ext cx="1722831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6" name="Rounded Rectangle 10"/>
            <p:cNvSpPr/>
            <p:nvPr/>
          </p:nvSpPr>
          <p:spPr>
            <a:xfrm>
              <a:off x="360986" y="1432955"/>
              <a:ext cx="1693223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i="0" kern="1200" dirty="0" smtClean="0"/>
                <a:t>Trimmed FASTA sequences </a:t>
              </a:r>
            </a:p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i="0" kern="1200" dirty="0" smtClean="0"/>
                <a:t>(&lt;15 </a:t>
              </a:r>
              <a:r>
                <a:rPr lang="en-US" sz="1000" b="1" i="0" kern="1200" dirty="0" err="1" smtClean="0"/>
                <a:t>bp</a:t>
              </a:r>
              <a:r>
                <a:rPr lang="en-US" sz="1000" b="1" i="0" kern="1200" dirty="0" smtClean="0"/>
                <a:t>)</a:t>
              </a:r>
              <a:endParaRPr lang="en-US" sz="1000" b="1" i="0" kern="1200" dirty="0"/>
            </a:p>
          </p:txBody>
        </p:sp>
      </p:grpSp>
      <p:sp>
        <p:nvSpPr>
          <p:cNvPr id="7" name="Straight Connector 11"/>
          <p:cNvSpPr/>
          <p:nvPr/>
        </p:nvSpPr>
        <p:spPr>
          <a:xfrm>
            <a:off x="2906638" y="1558877"/>
            <a:ext cx="975139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101087"/>
                </a:lnTo>
                <a:lnTo>
                  <a:pt x="975139" y="101087"/>
                </a:lnTo>
                <a:lnTo>
                  <a:pt x="975139" y="202175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8" name="Group 7"/>
          <p:cNvGrpSpPr/>
          <p:nvPr/>
        </p:nvGrpSpPr>
        <p:grpSpPr>
          <a:xfrm>
            <a:off x="3020362" y="1761052"/>
            <a:ext cx="1722831" cy="505438"/>
            <a:chOff x="2296461" y="1418151"/>
            <a:chExt cx="1722831" cy="505438"/>
          </a:xfrm>
        </p:grpSpPr>
        <p:sp>
          <p:nvSpPr>
            <p:cNvPr id="53" name="Rounded Rectangle 52"/>
            <p:cNvSpPr/>
            <p:nvPr/>
          </p:nvSpPr>
          <p:spPr>
            <a:xfrm>
              <a:off x="2296461" y="1418151"/>
              <a:ext cx="1722831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4" name="Rounded Rectangle 13"/>
            <p:cNvSpPr/>
            <p:nvPr/>
          </p:nvSpPr>
          <p:spPr>
            <a:xfrm>
              <a:off x="2311265" y="1432955"/>
              <a:ext cx="1693223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i="0" kern="1200" dirty="0" smtClean="0"/>
                <a:t>Trimmed FASTA sequences </a:t>
              </a:r>
            </a:p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i="0" kern="1200" dirty="0" smtClean="0"/>
                <a:t>(&gt;15) </a:t>
              </a:r>
              <a:r>
                <a:rPr lang="en-US" sz="1000" b="1" i="0" kern="1200" dirty="0" err="1" smtClean="0"/>
                <a:t>bp</a:t>
              </a:r>
              <a:r>
                <a:rPr lang="en-US" sz="1000" b="1" i="0" kern="1200" dirty="0" smtClean="0"/>
                <a:t>)</a:t>
              </a:r>
              <a:endParaRPr lang="en-US" sz="1000" b="1" i="0" kern="1200" dirty="0"/>
            </a:p>
          </p:txBody>
        </p:sp>
      </p:grpSp>
      <p:sp>
        <p:nvSpPr>
          <p:cNvPr id="9" name="Straight Connector 14"/>
          <p:cNvSpPr/>
          <p:nvPr/>
        </p:nvSpPr>
        <p:spPr>
          <a:xfrm>
            <a:off x="3836058" y="2266491"/>
            <a:ext cx="91440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45720" y="0"/>
                </a:moveTo>
                <a:lnTo>
                  <a:pt x="45720" y="202175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10" name="Group 9"/>
          <p:cNvGrpSpPr/>
          <p:nvPr/>
        </p:nvGrpSpPr>
        <p:grpSpPr>
          <a:xfrm>
            <a:off x="3306370" y="2468667"/>
            <a:ext cx="1150816" cy="505438"/>
            <a:chOff x="2582469" y="2125766"/>
            <a:chExt cx="1150816" cy="505438"/>
          </a:xfrm>
        </p:grpSpPr>
        <p:sp>
          <p:nvSpPr>
            <p:cNvPr id="51" name="Rounded Rectangle 50"/>
            <p:cNvSpPr/>
            <p:nvPr/>
          </p:nvSpPr>
          <p:spPr>
            <a:xfrm>
              <a:off x="2582469" y="2125766"/>
              <a:ext cx="1150816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2" name="Rounded Rectangle 16"/>
            <p:cNvSpPr/>
            <p:nvPr/>
          </p:nvSpPr>
          <p:spPr>
            <a:xfrm>
              <a:off x="2597273" y="2140570"/>
              <a:ext cx="1121208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Alignment to contaminants</a:t>
              </a:r>
              <a:endParaRPr lang="en-US" sz="1000" b="1" kern="1200" dirty="0"/>
            </a:p>
          </p:txBody>
        </p:sp>
      </p:grpSp>
      <p:sp>
        <p:nvSpPr>
          <p:cNvPr id="11" name="Straight Connector 17"/>
          <p:cNvSpPr/>
          <p:nvPr/>
        </p:nvSpPr>
        <p:spPr>
          <a:xfrm>
            <a:off x="3192646" y="2974105"/>
            <a:ext cx="689131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689131" y="0"/>
                </a:moveTo>
                <a:lnTo>
                  <a:pt x="689131" y="101087"/>
                </a:lnTo>
                <a:lnTo>
                  <a:pt x="0" y="101087"/>
                </a:lnTo>
                <a:lnTo>
                  <a:pt x="0" y="202175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12" name="Group 11"/>
          <p:cNvGrpSpPr/>
          <p:nvPr/>
        </p:nvGrpSpPr>
        <p:grpSpPr>
          <a:xfrm>
            <a:off x="2617238" y="3176281"/>
            <a:ext cx="1150816" cy="505438"/>
            <a:chOff x="1893337" y="2833380"/>
            <a:chExt cx="1150816" cy="505438"/>
          </a:xfrm>
        </p:grpSpPr>
        <p:sp>
          <p:nvSpPr>
            <p:cNvPr id="49" name="Rounded Rectangle 48"/>
            <p:cNvSpPr/>
            <p:nvPr/>
          </p:nvSpPr>
          <p:spPr>
            <a:xfrm>
              <a:off x="1893337" y="2833380"/>
              <a:ext cx="1150816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0" name="Rounded Rectangle 19"/>
            <p:cNvSpPr/>
            <p:nvPr/>
          </p:nvSpPr>
          <p:spPr>
            <a:xfrm>
              <a:off x="1908141" y="2848184"/>
              <a:ext cx="1121208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Matched contaminant sequences</a:t>
              </a:r>
              <a:endParaRPr lang="en-US" sz="1000" b="1" kern="1200" dirty="0"/>
            </a:p>
          </p:txBody>
        </p:sp>
      </p:grpSp>
      <p:sp>
        <p:nvSpPr>
          <p:cNvPr id="13" name="Straight Connector 20"/>
          <p:cNvSpPr/>
          <p:nvPr/>
        </p:nvSpPr>
        <p:spPr>
          <a:xfrm>
            <a:off x="3881778" y="2974105"/>
            <a:ext cx="689131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101087"/>
                </a:lnTo>
                <a:lnTo>
                  <a:pt x="689131" y="101087"/>
                </a:lnTo>
                <a:lnTo>
                  <a:pt x="689131" y="202175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14" name="Group 13"/>
          <p:cNvGrpSpPr/>
          <p:nvPr/>
        </p:nvGrpSpPr>
        <p:grpSpPr>
          <a:xfrm>
            <a:off x="3995502" y="3176281"/>
            <a:ext cx="1150816" cy="505438"/>
            <a:chOff x="3271601" y="2833380"/>
            <a:chExt cx="1150816" cy="505438"/>
          </a:xfrm>
        </p:grpSpPr>
        <p:sp>
          <p:nvSpPr>
            <p:cNvPr id="47" name="Rounded Rectangle 46"/>
            <p:cNvSpPr/>
            <p:nvPr/>
          </p:nvSpPr>
          <p:spPr>
            <a:xfrm>
              <a:off x="3271601" y="2833380"/>
              <a:ext cx="1150816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8" name="Rounded Rectangle 22"/>
            <p:cNvSpPr/>
            <p:nvPr/>
          </p:nvSpPr>
          <p:spPr>
            <a:xfrm>
              <a:off x="3286405" y="2848184"/>
              <a:ext cx="1121208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Unmatched sequences</a:t>
              </a:r>
              <a:endParaRPr lang="en-US" sz="1000" b="1" kern="1200" dirty="0"/>
            </a:p>
          </p:txBody>
        </p:sp>
      </p:grpSp>
      <p:sp>
        <p:nvSpPr>
          <p:cNvPr id="15" name="Straight Connector 23"/>
          <p:cNvSpPr/>
          <p:nvPr/>
        </p:nvSpPr>
        <p:spPr>
          <a:xfrm>
            <a:off x="3537212" y="3681720"/>
            <a:ext cx="1033697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1033697" y="0"/>
                </a:moveTo>
                <a:lnTo>
                  <a:pt x="1033697" y="101087"/>
                </a:lnTo>
                <a:lnTo>
                  <a:pt x="0" y="101087"/>
                </a:lnTo>
                <a:lnTo>
                  <a:pt x="0" y="202175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16" name="Group 15"/>
          <p:cNvGrpSpPr/>
          <p:nvPr/>
        </p:nvGrpSpPr>
        <p:grpSpPr>
          <a:xfrm>
            <a:off x="2770236" y="3883896"/>
            <a:ext cx="1533951" cy="505438"/>
            <a:chOff x="2046335" y="3540995"/>
            <a:chExt cx="1533951" cy="505438"/>
          </a:xfrm>
        </p:grpSpPr>
        <p:sp>
          <p:nvSpPr>
            <p:cNvPr id="45" name="Rounded Rectangle 44"/>
            <p:cNvSpPr/>
            <p:nvPr/>
          </p:nvSpPr>
          <p:spPr>
            <a:xfrm>
              <a:off x="2046335" y="3540995"/>
              <a:ext cx="1533951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6" name="Rounded Rectangle 25"/>
            <p:cNvSpPr/>
            <p:nvPr/>
          </p:nvSpPr>
          <p:spPr>
            <a:xfrm>
              <a:off x="2061139" y="3555799"/>
              <a:ext cx="1504343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Alignment to </a:t>
              </a:r>
            </a:p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reference genomes</a:t>
              </a:r>
              <a:endParaRPr lang="en-US" sz="1000" b="1" kern="1200" dirty="0"/>
            </a:p>
          </p:txBody>
        </p:sp>
      </p:grpSp>
      <p:sp>
        <p:nvSpPr>
          <p:cNvPr id="17" name="Straight Connector 26"/>
          <p:cNvSpPr/>
          <p:nvPr/>
        </p:nvSpPr>
        <p:spPr>
          <a:xfrm>
            <a:off x="3491492" y="4389334"/>
            <a:ext cx="91440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45720" y="0"/>
                </a:moveTo>
                <a:lnTo>
                  <a:pt x="45720" y="202175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18" name="Group 17"/>
          <p:cNvGrpSpPr/>
          <p:nvPr/>
        </p:nvGrpSpPr>
        <p:grpSpPr>
          <a:xfrm>
            <a:off x="2961804" y="4591510"/>
            <a:ext cx="1150816" cy="505438"/>
            <a:chOff x="2237903" y="4248609"/>
            <a:chExt cx="1150816" cy="505438"/>
          </a:xfrm>
        </p:grpSpPr>
        <p:sp>
          <p:nvSpPr>
            <p:cNvPr id="43" name="Rounded Rectangle 42"/>
            <p:cNvSpPr/>
            <p:nvPr/>
          </p:nvSpPr>
          <p:spPr>
            <a:xfrm>
              <a:off x="2237903" y="4248609"/>
              <a:ext cx="1150816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4" name="Rounded Rectangle 28"/>
            <p:cNvSpPr/>
            <p:nvPr/>
          </p:nvSpPr>
          <p:spPr>
            <a:xfrm>
              <a:off x="2252707" y="4263413"/>
              <a:ext cx="1121208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Matched reference sequences</a:t>
              </a:r>
              <a:endParaRPr lang="en-US" sz="1000" b="1" kern="1200" dirty="0"/>
            </a:p>
          </p:txBody>
        </p:sp>
      </p:grpSp>
      <p:sp>
        <p:nvSpPr>
          <p:cNvPr id="19" name="Straight Connector 29"/>
          <p:cNvSpPr/>
          <p:nvPr/>
        </p:nvSpPr>
        <p:spPr>
          <a:xfrm>
            <a:off x="4570910" y="3681720"/>
            <a:ext cx="1149066" cy="20448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102240"/>
                </a:lnTo>
                <a:lnTo>
                  <a:pt x="1149066" y="102240"/>
                </a:lnTo>
                <a:lnTo>
                  <a:pt x="1149066" y="204480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20" name="Group 19"/>
          <p:cNvGrpSpPr/>
          <p:nvPr/>
        </p:nvGrpSpPr>
        <p:grpSpPr>
          <a:xfrm>
            <a:off x="4953001" y="3886200"/>
            <a:ext cx="1533951" cy="505438"/>
            <a:chOff x="4229100" y="3543299"/>
            <a:chExt cx="1533951" cy="505438"/>
          </a:xfrm>
        </p:grpSpPr>
        <p:sp>
          <p:nvSpPr>
            <p:cNvPr id="41" name="Rounded Rectangle 40"/>
            <p:cNvSpPr/>
            <p:nvPr/>
          </p:nvSpPr>
          <p:spPr>
            <a:xfrm>
              <a:off x="4229100" y="3543299"/>
              <a:ext cx="1533951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2" name="Rounded Rectangle 31"/>
            <p:cNvSpPr/>
            <p:nvPr/>
          </p:nvSpPr>
          <p:spPr>
            <a:xfrm>
              <a:off x="4243904" y="3558103"/>
              <a:ext cx="1504343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Alignment to mature </a:t>
              </a:r>
              <a:r>
                <a:rPr lang="en-US" sz="1000" b="1" kern="1200" dirty="0" err="1" smtClean="0"/>
                <a:t>miRNAs</a:t>
              </a:r>
              <a:r>
                <a:rPr lang="en-US" sz="1000" b="1" kern="1200" dirty="0" smtClean="0"/>
                <a:t> in </a:t>
              </a:r>
              <a:r>
                <a:rPr lang="en-US" sz="1000" b="1" kern="1200" dirty="0" err="1" smtClean="0"/>
                <a:t>miRBase</a:t>
              </a:r>
              <a:endParaRPr lang="en-US" sz="1000" b="1" kern="1200" dirty="0"/>
            </a:p>
          </p:txBody>
        </p:sp>
      </p:grpSp>
      <p:sp>
        <p:nvSpPr>
          <p:cNvPr id="21" name="Straight Connector 32"/>
          <p:cNvSpPr/>
          <p:nvPr/>
        </p:nvSpPr>
        <p:spPr>
          <a:xfrm>
            <a:off x="4915476" y="4391639"/>
            <a:ext cx="804500" cy="19987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804500" y="0"/>
                </a:moveTo>
                <a:lnTo>
                  <a:pt x="804500" y="99935"/>
                </a:lnTo>
                <a:lnTo>
                  <a:pt x="0" y="99935"/>
                </a:lnTo>
                <a:lnTo>
                  <a:pt x="0" y="199870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22" name="Group 21"/>
          <p:cNvGrpSpPr/>
          <p:nvPr/>
        </p:nvGrpSpPr>
        <p:grpSpPr>
          <a:xfrm>
            <a:off x="4340068" y="4591510"/>
            <a:ext cx="1150816" cy="505438"/>
            <a:chOff x="3616167" y="4248609"/>
            <a:chExt cx="1150816" cy="505438"/>
          </a:xfrm>
        </p:grpSpPr>
        <p:sp>
          <p:nvSpPr>
            <p:cNvPr id="39" name="Rounded Rectangle 38"/>
            <p:cNvSpPr/>
            <p:nvPr/>
          </p:nvSpPr>
          <p:spPr>
            <a:xfrm>
              <a:off x="3616167" y="4248609"/>
              <a:ext cx="1150816" cy="505438"/>
            </a:xfrm>
            <a:prstGeom prst="roundRect">
              <a:avLst>
                <a:gd name="adj" fmla="val 10000"/>
              </a:avLst>
            </a:prstGeom>
            <a:solidFill>
              <a:schemeClr val="tx1"/>
            </a:solidFill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0" name="Rounded Rectangle 34"/>
            <p:cNvSpPr/>
            <p:nvPr/>
          </p:nvSpPr>
          <p:spPr>
            <a:xfrm>
              <a:off x="3630971" y="4263413"/>
              <a:ext cx="1121208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smtClean="0">
                  <a:solidFill>
                    <a:schemeClr val="bg1"/>
                  </a:solidFill>
                </a:rPr>
                <a:t>Matched mature miRNA sequences</a:t>
              </a:r>
              <a:endParaRPr lang="en-US" sz="1000" b="1" kern="1200" dirty="0">
                <a:solidFill>
                  <a:schemeClr val="bg1"/>
                </a:solidFill>
              </a:endParaRPr>
            </a:p>
          </p:txBody>
        </p:sp>
      </p:grpSp>
      <p:sp>
        <p:nvSpPr>
          <p:cNvPr id="23" name="Straight Connector 35"/>
          <p:cNvSpPr/>
          <p:nvPr/>
        </p:nvSpPr>
        <p:spPr>
          <a:xfrm>
            <a:off x="5719976" y="4391639"/>
            <a:ext cx="573762" cy="19987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99935"/>
                </a:lnTo>
                <a:lnTo>
                  <a:pt x="573762" y="99935"/>
                </a:lnTo>
                <a:lnTo>
                  <a:pt x="573762" y="199870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24" name="Group 23"/>
          <p:cNvGrpSpPr/>
          <p:nvPr/>
        </p:nvGrpSpPr>
        <p:grpSpPr>
          <a:xfrm>
            <a:off x="5718331" y="4591510"/>
            <a:ext cx="1150816" cy="505438"/>
            <a:chOff x="4994430" y="4248609"/>
            <a:chExt cx="1150816" cy="505438"/>
          </a:xfrm>
        </p:grpSpPr>
        <p:sp>
          <p:nvSpPr>
            <p:cNvPr id="37" name="Rounded Rectangle 36"/>
            <p:cNvSpPr/>
            <p:nvPr/>
          </p:nvSpPr>
          <p:spPr>
            <a:xfrm>
              <a:off x="4994430" y="4248609"/>
              <a:ext cx="1150816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8" name="Rounded Rectangle 37"/>
            <p:cNvSpPr/>
            <p:nvPr/>
          </p:nvSpPr>
          <p:spPr>
            <a:xfrm>
              <a:off x="5009234" y="4263413"/>
              <a:ext cx="1121208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Unmatched sequences</a:t>
              </a:r>
              <a:endParaRPr lang="en-US" sz="1000" b="1" kern="1200" dirty="0"/>
            </a:p>
          </p:txBody>
        </p:sp>
      </p:grpSp>
      <p:sp>
        <p:nvSpPr>
          <p:cNvPr id="25" name="Straight Connector 38"/>
          <p:cNvSpPr/>
          <p:nvPr/>
        </p:nvSpPr>
        <p:spPr>
          <a:xfrm>
            <a:off x="6248019" y="5096949"/>
            <a:ext cx="91440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45720" y="0"/>
                </a:moveTo>
                <a:lnTo>
                  <a:pt x="45720" y="202175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26" name="Group 25"/>
          <p:cNvGrpSpPr/>
          <p:nvPr/>
        </p:nvGrpSpPr>
        <p:grpSpPr>
          <a:xfrm>
            <a:off x="5609581" y="5299124"/>
            <a:ext cx="1368316" cy="505438"/>
            <a:chOff x="4885680" y="4956223"/>
            <a:chExt cx="1368316" cy="505438"/>
          </a:xfrm>
        </p:grpSpPr>
        <p:sp>
          <p:nvSpPr>
            <p:cNvPr id="35" name="Rounded Rectangle 34"/>
            <p:cNvSpPr/>
            <p:nvPr/>
          </p:nvSpPr>
          <p:spPr>
            <a:xfrm>
              <a:off x="4885680" y="4956223"/>
              <a:ext cx="1368316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6" name="Rounded Rectangle 40"/>
            <p:cNvSpPr/>
            <p:nvPr/>
          </p:nvSpPr>
          <p:spPr>
            <a:xfrm>
              <a:off x="4900484" y="4971027"/>
              <a:ext cx="1338708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Alignment to precursor </a:t>
              </a:r>
              <a:r>
                <a:rPr lang="en-US" sz="1000" b="1" kern="1200" dirty="0" err="1" smtClean="0"/>
                <a:t>miRNAs</a:t>
              </a:r>
              <a:r>
                <a:rPr lang="en-US" sz="1000" b="1" kern="1200" dirty="0" smtClean="0"/>
                <a:t> in </a:t>
              </a:r>
              <a:r>
                <a:rPr lang="en-US" sz="1000" b="1" kern="1200" dirty="0" err="1" smtClean="0"/>
                <a:t>miRBase</a:t>
              </a:r>
              <a:endParaRPr lang="en-US" sz="1000" b="1" kern="1200" dirty="0"/>
            </a:p>
          </p:txBody>
        </p:sp>
      </p:grpSp>
      <p:sp>
        <p:nvSpPr>
          <p:cNvPr id="27" name="Straight Connector 41"/>
          <p:cNvSpPr/>
          <p:nvPr/>
        </p:nvSpPr>
        <p:spPr>
          <a:xfrm>
            <a:off x="5346788" y="5804563"/>
            <a:ext cx="946951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946951" y="0"/>
                </a:moveTo>
                <a:lnTo>
                  <a:pt x="946951" y="101087"/>
                </a:lnTo>
                <a:lnTo>
                  <a:pt x="0" y="101087"/>
                </a:lnTo>
                <a:lnTo>
                  <a:pt x="0" y="202175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28" name="Group 27"/>
          <p:cNvGrpSpPr/>
          <p:nvPr/>
        </p:nvGrpSpPr>
        <p:grpSpPr>
          <a:xfrm>
            <a:off x="4513561" y="6006739"/>
            <a:ext cx="1666454" cy="505438"/>
            <a:chOff x="3789660" y="5663838"/>
            <a:chExt cx="1666454" cy="505438"/>
          </a:xfrm>
        </p:grpSpPr>
        <p:sp>
          <p:nvSpPr>
            <p:cNvPr id="33" name="Rounded Rectangle 32"/>
            <p:cNvSpPr/>
            <p:nvPr/>
          </p:nvSpPr>
          <p:spPr>
            <a:xfrm>
              <a:off x="3789660" y="5663838"/>
              <a:ext cx="1666454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4" name="Rounded Rectangle 43"/>
            <p:cNvSpPr/>
            <p:nvPr/>
          </p:nvSpPr>
          <p:spPr>
            <a:xfrm>
              <a:off x="3804464" y="5678642"/>
              <a:ext cx="1636846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Matched precursor </a:t>
              </a:r>
            </a:p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err="1" smtClean="0"/>
                <a:t>miRNA</a:t>
              </a:r>
              <a:r>
                <a:rPr lang="en-US" sz="1000" b="1" kern="1200" dirty="0" smtClean="0"/>
                <a:t> sequences</a:t>
              </a:r>
              <a:endParaRPr lang="en-US" sz="1000" b="1" kern="1200" dirty="0"/>
            </a:p>
          </p:txBody>
        </p:sp>
      </p:grpSp>
      <p:sp>
        <p:nvSpPr>
          <p:cNvPr id="29" name="Straight Connector 44"/>
          <p:cNvSpPr/>
          <p:nvPr/>
        </p:nvSpPr>
        <p:spPr>
          <a:xfrm>
            <a:off x="6293739" y="5804563"/>
            <a:ext cx="946951" cy="202175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101087"/>
                </a:lnTo>
                <a:lnTo>
                  <a:pt x="946951" y="101087"/>
                </a:lnTo>
                <a:lnTo>
                  <a:pt x="946951" y="202175"/>
                </a:lnTo>
              </a:path>
            </a:pathLst>
          </a:custGeom>
          <a:noFill/>
        </p:spPr>
        <p:style>
          <a:lnRef idx="2">
            <a:schemeClr val="dk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dk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grpSp>
        <p:nvGrpSpPr>
          <p:cNvPr id="30" name="Group 29"/>
          <p:cNvGrpSpPr/>
          <p:nvPr/>
        </p:nvGrpSpPr>
        <p:grpSpPr>
          <a:xfrm>
            <a:off x="6407463" y="6006739"/>
            <a:ext cx="1666454" cy="505438"/>
            <a:chOff x="5683562" y="5663838"/>
            <a:chExt cx="1666454" cy="505438"/>
          </a:xfrm>
        </p:grpSpPr>
        <p:sp>
          <p:nvSpPr>
            <p:cNvPr id="31" name="Rounded Rectangle 30"/>
            <p:cNvSpPr/>
            <p:nvPr/>
          </p:nvSpPr>
          <p:spPr>
            <a:xfrm>
              <a:off x="5683562" y="5663838"/>
              <a:ext cx="1666454" cy="505438"/>
            </a:xfrm>
            <a:prstGeom prst="roundRect">
              <a:avLst>
                <a:gd name="adj" fmla="val 10000"/>
              </a:avLst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2" name="Rounded Rectangle 46"/>
            <p:cNvSpPr/>
            <p:nvPr/>
          </p:nvSpPr>
          <p:spPr>
            <a:xfrm>
              <a:off x="5698366" y="5678642"/>
              <a:ext cx="1636846" cy="47583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Autofit/>
            </a:bodyPr>
            <a:lstStyle/>
            <a:p>
              <a:pPr lvl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 smtClean="0"/>
                <a:t>Unmatched sequences</a:t>
              </a:r>
              <a:endParaRPr lang="en-US" sz="1000" b="1" kern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180431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63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MRC-Frederic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ohit Patel</dc:creator>
  <cp:lastModifiedBy>Cer, Regina CTR NMRC</cp:lastModifiedBy>
  <cp:revision>20</cp:revision>
  <dcterms:created xsi:type="dcterms:W3CDTF">2017-06-12T17:42:26Z</dcterms:created>
  <dcterms:modified xsi:type="dcterms:W3CDTF">2017-06-19T19:06:21Z</dcterms:modified>
</cp:coreProperties>
</file>